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4" r:id="rId2"/>
  </p:sldIdLst>
  <p:sldSz cx="6858000" cy="9906000" type="A4"/>
  <p:notesSz cx="6797675" cy="99282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llemlayout 2 - Markering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05" d="100"/>
          <a:sy n="105" d="100"/>
        </p:scale>
        <p:origin x="4380" y="1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asper Søndenbroe" userId="f8776a83-b8c2-44e5-a16c-5099330b3ce0" providerId="ADAL" clId="{3EEC3353-E3D2-472A-9BD1-A05E9B88ACD0}"/>
    <pc:docChg chg="custSel addSld delSld modSld">
      <pc:chgData name="Casper Søndenbroe" userId="f8776a83-b8c2-44e5-a16c-5099330b3ce0" providerId="ADAL" clId="{3EEC3353-E3D2-472A-9BD1-A05E9B88ACD0}" dt="2025-12-01T12:16:07.248" v="8" actId="47"/>
      <pc:docMkLst>
        <pc:docMk/>
      </pc:docMkLst>
      <pc:sldChg chg="addSp delSp modSp add del mod">
        <pc:chgData name="Casper Søndenbroe" userId="f8776a83-b8c2-44e5-a16c-5099330b3ce0" providerId="ADAL" clId="{3EEC3353-E3D2-472A-9BD1-A05E9B88ACD0}" dt="2025-12-01T12:16:07.248" v="8" actId="47"/>
        <pc:sldMkLst>
          <pc:docMk/>
          <pc:sldMk cId="4039565954" sldId="265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a-DK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463F187-BFD0-472B-82C5-C716981D6D73}" type="datetimeFigureOut">
              <a:rPr lang="da-DK" smtClean="0"/>
              <a:t>01-12-2025</a:t>
            </a:fld>
            <a:endParaRPr lang="da-DK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a-DK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78375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a-DK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a-DK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0A5C0B6-63EE-4F94-9A09-8B0AB3ECA14A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78250128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0A5C0B6-63EE-4F94-9A09-8B0AB3ECA14A}" type="slidenum">
              <a:rPr lang="da-DK" smtClean="0"/>
              <a:t>1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43763684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a-DK"/>
              <a:t>Klik for at redigere undertiteltypografien i master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0F578F-DC4B-4A3C-92A3-221A8304D036}" type="datetimeFigureOut">
              <a:rPr lang="en-US" smtClean="0"/>
              <a:t>12/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8989B-1907-48AD-9AEA-0D7FE815C1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24062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og lodret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0F578F-DC4B-4A3C-92A3-221A8304D036}" type="datetimeFigureOut">
              <a:rPr lang="en-US" smtClean="0"/>
              <a:t>12/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8989B-1907-48AD-9AEA-0D7FE815C1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28255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et titel og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0F578F-DC4B-4A3C-92A3-221A8304D036}" type="datetimeFigureOut">
              <a:rPr lang="en-US" smtClean="0"/>
              <a:t>12/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8989B-1907-48AD-9AEA-0D7FE815C1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89272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og indholdsobjek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0F578F-DC4B-4A3C-92A3-221A8304D036}" type="datetimeFigureOut">
              <a:rPr lang="en-US" smtClean="0"/>
              <a:t>12/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8989B-1907-48AD-9AEA-0D7FE815C1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01395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fsnitsoversk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0F578F-DC4B-4A3C-92A3-221A8304D036}" type="datetimeFigureOut">
              <a:rPr lang="en-US" smtClean="0"/>
              <a:t>12/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8989B-1907-48AD-9AEA-0D7FE815C1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19706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o indholdsobjekt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0F578F-DC4B-4A3C-92A3-221A8304D036}" type="datetimeFigureOut">
              <a:rPr lang="en-US" smtClean="0"/>
              <a:t>12/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8989B-1907-48AD-9AEA-0D7FE815C1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35139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Sammenlign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0F578F-DC4B-4A3C-92A3-221A8304D036}" type="datetimeFigureOut">
              <a:rPr lang="en-US" smtClean="0"/>
              <a:t>12/1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8989B-1907-48AD-9AEA-0D7FE815C1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73532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Ku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0F578F-DC4B-4A3C-92A3-221A8304D036}" type="datetimeFigureOut">
              <a:rPr lang="en-US" smtClean="0"/>
              <a:t>12/1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8989B-1907-48AD-9AEA-0D7FE815C1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99417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0F578F-DC4B-4A3C-92A3-221A8304D036}" type="datetimeFigureOut">
              <a:rPr lang="en-US" smtClean="0"/>
              <a:t>12/1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8989B-1907-48AD-9AEA-0D7FE815C1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01791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dhold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0F578F-DC4B-4A3C-92A3-221A8304D036}" type="datetimeFigureOut">
              <a:rPr lang="en-US" smtClean="0"/>
              <a:t>12/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8989B-1907-48AD-9AEA-0D7FE815C1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00828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lede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a-DK"/>
              <a:t>Klik på ikonet for at tilføje et billed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0F578F-DC4B-4A3C-92A3-221A8304D036}" type="datetimeFigureOut">
              <a:rPr lang="en-US" smtClean="0"/>
              <a:t>12/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8989B-1907-48AD-9AEA-0D7FE815C1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04850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90F578F-DC4B-4A3C-92A3-221A8304D036}" type="datetimeFigureOut">
              <a:rPr lang="en-US" smtClean="0"/>
              <a:t>12/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5C8989B-1907-48AD-9AEA-0D7FE815C1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97112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0555038-65C7-78C7-3D42-42C674FE46E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kstfelt 3">
            <a:extLst>
              <a:ext uri="{FF2B5EF4-FFF2-40B4-BE49-F238E27FC236}">
                <a16:creationId xmlns:a16="http://schemas.microsoft.com/office/drawing/2014/main" id="{46825DA2-7DD9-CF8D-E932-C824FECD562F}"/>
              </a:ext>
            </a:extLst>
          </p:cNvPr>
          <p:cNvSpPr txBox="1"/>
          <p:nvPr/>
        </p:nvSpPr>
        <p:spPr>
          <a:xfrm>
            <a:off x="2153877" y="0"/>
            <a:ext cx="255025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000" dirty="0"/>
              <a:t>Supplemental table 1</a:t>
            </a:r>
          </a:p>
        </p:txBody>
      </p:sp>
      <p:graphicFrame>
        <p:nvGraphicFramePr>
          <p:cNvPr id="2" name="Tabel 1">
            <a:extLst>
              <a:ext uri="{FF2B5EF4-FFF2-40B4-BE49-F238E27FC236}">
                <a16:creationId xmlns:a16="http://schemas.microsoft.com/office/drawing/2014/main" id="{187E84EC-5D25-8998-4CBE-33E6CF91165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08507114"/>
              </p:ext>
            </p:extLst>
          </p:nvPr>
        </p:nvGraphicFramePr>
        <p:xfrm>
          <a:off x="660399" y="1645444"/>
          <a:ext cx="5537202" cy="1390650"/>
        </p:xfrm>
        <a:graphic>
          <a:graphicData uri="http://schemas.openxmlformats.org/drawingml/2006/table">
            <a:tbl>
              <a:tblPr/>
              <a:tblGrid>
                <a:gridCol w="1975296">
                  <a:extLst>
                    <a:ext uri="{9D8B030D-6E8A-4147-A177-3AD203B41FA5}">
                      <a16:colId xmlns:a16="http://schemas.microsoft.com/office/drawing/2014/main" val="682980390"/>
                    </a:ext>
                  </a:extLst>
                </a:gridCol>
                <a:gridCol w="522498">
                  <a:extLst>
                    <a:ext uri="{9D8B030D-6E8A-4147-A177-3AD203B41FA5}">
                      <a16:colId xmlns:a16="http://schemas.microsoft.com/office/drawing/2014/main" val="578441180"/>
                    </a:ext>
                  </a:extLst>
                </a:gridCol>
                <a:gridCol w="516126">
                  <a:extLst>
                    <a:ext uri="{9D8B030D-6E8A-4147-A177-3AD203B41FA5}">
                      <a16:colId xmlns:a16="http://schemas.microsoft.com/office/drawing/2014/main" val="1162854307"/>
                    </a:ext>
                  </a:extLst>
                </a:gridCol>
                <a:gridCol w="516126">
                  <a:extLst>
                    <a:ext uri="{9D8B030D-6E8A-4147-A177-3AD203B41FA5}">
                      <a16:colId xmlns:a16="http://schemas.microsoft.com/office/drawing/2014/main" val="2125728616"/>
                    </a:ext>
                  </a:extLst>
                </a:gridCol>
                <a:gridCol w="410989">
                  <a:extLst>
                    <a:ext uri="{9D8B030D-6E8A-4147-A177-3AD203B41FA5}">
                      <a16:colId xmlns:a16="http://schemas.microsoft.com/office/drawing/2014/main" val="2064274418"/>
                    </a:ext>
                  </a:extLst>
                </a:gridCol>
                <a:gridCol w="152926">
                  <a:extLst>
                    <a:ext uri="{9D8B030D-6E8A-4147-A177-3AD203B41FA5}">
                      <a16:colId xmlns:a16="http://schemas.microsoft.com/office/drawing/2014/main" val="376251491"/>
                    </a:ext>
                  </a:extLst>
                </a:gridCol>
                <a:gridCol w="516126">
                  <a:extLst>
                    <a:ext uri="{9D8B030D-6E8A-4147-A177-3AD203B41FA5}">
                      <a16:colId xmlns:a16="http://schemas.microsoft.com/office/drawing/2014/main" val="3571121121"/>
                    </a:ext>
                  </a:extLst>
                </a:gridCol>
                <a:gridCol w="516126">
                  <a:extLst>
                    <a:ext uri="{9D8B030D-6E8A-4147-A177-3AD203B41FA5}">
                      <a16:colId xmlns:a16="http://schemas.microsoft.com/office/drawing/2014/main" val="2308621229"/>
                    </a:ext>
                  </a:extLst>
                </a:gridCol>
                <a:gridCol w="410989">
                  <a:extLst>
                    <a:ext uri="{9D8B030D-6E8A-4147-A177-3AD203B41FA5}">
                      <a16:colId xmlns:a16="http://schemas.microsoft.com/office/drawing/2014/main" val="2591235811"/>
                    </a:ext>
                  </a:extLst>
                </a:gridCol>
              </a:tblGrid>
              <a:tr h="200025">
                <a:tc>
                  <a:txBody>
                    <a:bodyPr/>
                    <a:lstStyle/>
                    <a:p>
                      <a:pPr algn="l" fontAlgn="b"/>
                      <a:r>
                        <a:rPr lang="da-DK" sz="11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a-DK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da-DK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e to 8wk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da-DK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a-DK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a-DK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da-DK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e to 16wk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da-DK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a-DK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02748520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l" fontAlgn="b"/>
                      <a:r>
                        <a:rPr lang="da-DK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ariabl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a-DK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a-DK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SDlos-sed</a:t>
                      </a:r>
                      <a:endParaRPr lang="da-DK" sz="800" b="0" i="1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a-DK" sz="800" b="0" i="1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SDlos-ex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a-DK" sz="8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Dir</a:t>
                      </a:r>
                      <a:endParaRPr lang="da-DK" sz="8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da-DK" sz="8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a-DK" sz="800" b="0" i="1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SDlos-sed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a-DK" sz="800" b="0" i="1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SDlos-ex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a-DK" sz="8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Dir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42011705"/>
                  </a:ext>
                </a:extLst>
              </a:tr>
              <a:tr h="219075">
                <a:tc>
                  <a:txBody>
                    <a:bodyPr/>
                    <a:lstStyle/>
                    <a:p>
                      <a:pPr algn="l" fontAlgn="ctr"/>
                      <a:r>
                        <a:rPr lang="da-DK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ximal voluntary contraction [Nm]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a-DK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a-DK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a-DK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a-DK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a-DK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a-DK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a-DK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a-DK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525099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ate of force development [Nm/s]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a-DK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a-DK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3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a-DK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6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a-DK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a-DK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a-DK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4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a-DK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2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a-DK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8018039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da-DK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Quadriceps CSA [cm^2]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a-DK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a-DK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a-DK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a-DK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89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a-DK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a-DK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a-DK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a-DK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53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7617424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ctr"/>
                      <a:r>
                        <a:rPr lang="da-DK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ype I fCSA [</a:t>
                      </a:r>
                      <a:r>
                        <a:rPr lang="el-GR" sz="10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μ</a:t>
                      </a:r>
                      <a:r>
                        <a:rPr lang="da-DK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^2]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a-DK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6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a-DK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5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a-DK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9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a-DK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47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da-DK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a-DK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3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a-DK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6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a-DK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1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81247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l" fontAlgn="ctr"/>
                      <a:r>
                        <a:rPr lang="da-DK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ype II fCSA [</a:t>
                      </a:r>
                      <a:r>
                        <a:rPr lang="el-GR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μ</a:t>
                      </a:r>
                      <a:r>
                        <a:rPr lang="da-DK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^2]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a-DK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8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a-DK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3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a-DK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6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a-DK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4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a-DK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a-DK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9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a-DK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4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a-DK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2419790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1787287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-tema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-tema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-te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981</TotalTime>
  <Words>103</Words>
  <Application>Microsoft Office PowerPoint</Application>
  <PresentationFormat>A4 Paper (210x297 mm)</PresentationFormat>
  <Paragraphs>57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ptos</vt:lpstr>
      <vt:lpstr>Aptos Display</vt:lpstr>
      <vt:lpstr>Aptos Narrow</vt:lpstr>
      <vt:lpstr>Arial</vt:lpstr>
      <vt:lpstr>Calibri</vt:lpstr>
      <vt:lpstr>Office-tema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æsentation</dc:title>
  <dc:creator>Casper Søndenbroe</dc:creator>
  <cp:lastModifiedBy>Casper Søndenbroe</cp:lastModifiedBy>
  <cp:revision>41</cp:revision>
  <cp:lastPrinted>2025-03-21T12:49:11Z</cp:lastPrinted>
  <dcterms:created xsi:type="dcterms:W3CDTF">2024-12-16T19:08:23Z</dcterms:created>
  <dcterms:modified xsi:type="dcterms:W3CDTF">2025-12-01T12:16:11Z</dcterms:modified>
</cp:coreProperties>
</file>